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7D6036-3188-4F46-988E-24D63BC633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3ADEC0-D748-485B-9F0A-54C16037DC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AAD7E-98A2-4931-BBB3-BC67EF0226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90345-932A-428C-ACFA-CCD6ACF0C9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B95898-9BFF-43FA-A835-D4B386A159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8ED6A-C823-402E-9631-D78A3A617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0F9A1-E1D8-419A-BB61-3E60D748F2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09A21-3E1E-4EBA-BFF6-3767474A9B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3FF9F-3821-479D-89CA-29EABF721D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9BDDFF-07A6-4D67-8801-9FACD3C7E6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FEC2B2-1BD1-4716-9B66-26CA578D54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BD975-FD16-487F-AE42-FFB9034ECD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0CE68F-33FA-4F5C-AE1A-6E823A3F9FFF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6" descr=""/>
          <p:cNvPicPr/>
          <p:nvPr/>
        </p:nvPicPr>
        <p:blipFill>
          <a:blip r:embed="rId1"/>
          <a:stretch/>
        </p:blipFill>
        <p:spPr>
          <a:xfrm>
            <a:off x="2212920" y="841320"/>
            <a:ext cx="7309080" cy="46450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8"/>
          <p:cNvSpPr/>
          <p:nvPr/>
        </p:nvSpPr>
        <p:spPr>
          <a:xfrm>
            <a:off x="3035520" y="1382760"/>
            <a:ext cx="99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=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0.023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2438280" y="5565600"/>
            <a:ext cx="76201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ar</a:t>
            </a:r>
            <a:r>
              <a:rPr b="1" i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evels are significantly reduced in OP9-K cells after treatment with RNAi against Ppar</a:t>
            </a:r>
            <a:r>
              <a:rPr b="1" i="1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γ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levels were measuring using relative quantification RT-PCR with biological and technical replicates.  Expression levels are shown relative to OP9-K cells treated with negative control RNAi.  p-value represents the significance level of knock down as calculated with a t-test.  Error bars represent the 95% confidence interval.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8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1T22:26:13Z</dcterms:created>
  <dc:creator>jackie l.</dc:creator>
  <dc:description/>
  <dc:language>en-US</dc:language>
  <cp:lastModifiedBy>Kosta</cp:lastModifiedBy>
  <dcterms:modified xsi:type="dcterms:W3CDTF">2014-10-29T23:07:13Z</dcterms:modified>
  <cp:revision>10</cp:revision>
  <dc:subject/>
  <dc:title>Slide 1</dc:title>
</cp:coreProperties>
</file>